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63" r:id="rId3"/>
    <p:sldId id="264" r:id="rId4"/>
    <p:sldId id="265" r:id="rId5"/>
    <p:sldId id="274" r:id="rId6"/>
    <p:sldId id="27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34"/>
    <p:restoredTop sz="94648"/>
  </p:normalViewPr>
  <p:slideViewPr>
    <p:cSldViewPr snapToGrid="0">
      <p:cViewPr varScale="1">
        <p:scale>
          <a:sx n="112" d="100"/>
          <a:sy n="112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888D2A-2548-9356-517F-392A63B311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5C01E1-3013-8625-1FE6-6F5BA6A90B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9F0A0E-DC74-2774-E168-A8381DB52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87B010-E36D-BD01-19C7-D37F10904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564CA1-8AB0-D754-6CBF-D2081CEBD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186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4EFE7-B1D7-BEE8-2E79-5C478C98F8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0290A6-EE44-32AD-84F9-974F3FBD84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CE391-B966-231B-558C-93DB9FD02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A8A988-214A-7AD8-05C1-150BDA0BC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CD6D0E-19AA-EA41-E348-A28E6D38A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191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241460-26AA-C30C-1FEA-D40F21B657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74B43F-6DDD-AD96-0DAF-1197A41693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F448FD-6C04-C169-FFE6-FE3E8E2F9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8BC26A-521F-77CD-D13B-E41F2EC70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3D7342-45CE-69C6-AA0D-AC10CE373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622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A35D6-2644-61FE-FA2B-5467D4979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4602B5-E09B-E995-072B-0A24D66790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A802B6-06CB-DDB0-F6B4-9D6F1B685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DDC42A-04D1-37E4-3693-49D61E117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0D5EEB-0919-6EC3-9831-9F788875E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683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ABD78-0640-D551-E081-19BEECFF7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60A834-3291-AD3D-3269-1A27BF9382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6637F5-D2C0-D02A-8416-7850ECA20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89B77-BD17-C846-716E-7E8F2B37A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7C81C-7775-F350-1FAD-11C16C7C9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12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C73335-5C7D-F2E9-004D-5DD42464D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F828A4-0A8B-7061-EBFE-5DE95D9CE8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C994EA-27EC-E468-D4A4-B4454C6D0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04E6F4-8B33-A014-F11E-A6E6CBEB6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D9577-6D5B-8E21-B67C-564100F45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CD5514-E4FA-8654-1BA2-124D9B184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88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5D5F1-BE9A-DC0D-85F5-F1348202B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437B0F-801F-B34A-5E27-451F04473E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3671DB-ACA2-56FA-005C-3BB7FBFEA3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5E111C-B149-E951-6BB3-2B6FDBFF0E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B5608D-6612-D6A5-EB8C-BC6FF4EC10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944C46-3FC3-A13A-7093-EC34C5604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C45489-6B8D-C579-77E9-FF639F7A6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4D7386-E1CA-0EC2-734E-34AFB99CB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51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B6269-89F4-E2DB-4F8C-4F0987113D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4D9B21-1D75-D5B3-34D5-418F51720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E04C2B-AD33-E469-E1C1-317BF5C745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894898-C1CC-AF71-86E3-7200AFF1F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983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9B6136-FC5C-4B11-6038-B3D86ACF6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D73856-0D7C-4954-C427-63A3B88AB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CE8FFF-284F-C865-DAB9-864DD70D4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523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8F87F-0368-D276-641A-F5753D780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163F9E-9F97-C7BA-0725-0AFC6A473F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EA512A-9F73-9995-B54C-BE540011C9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34323D-2265-84D8-AC8F-6B0E808A8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837C66-3260-C074-A3B2-F45244918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031249-F892-0152-531A-E09F379AE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29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C8DF8E-20B9-5184-4AA7-8E058C4A4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BF16EA-0739-1FD7-4EE2-F6356E41B6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3FE925-6F7C-EF22-14A0-B2C3AF392C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99CEDF-A397-C135-7BA8-C8C28430E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92679B-FBDB-FC97-9F8E-03A64A979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D00BE1-690B-2736-5A2B-216CEB999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731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C7E0D9-28BC-1091-2EE1-A46512584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080863-7632-56E3-B1C4-7AE36D146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9705B-3D62-A39E-3B90-18A82A43AF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725DDB-E212-C14E-AA23-E3656260CED0}" type="datetimeFigureOut">
              <a:rPr lang="en-US" smtClean="0"/>
              <a:t>7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70F70-095D-DC03-E681-A5313F27C6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ECE1F8-B613-187B-40D0-D78ECEEA65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D24D81-074A-AE4F-A6B0-A86CE1592D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7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82DFBE-8C11-F345-1D5D-857537D395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62AC18F-9E1F-DA9E-94CD-C0C71F172619}"/>
              </a:ext>
            </a:extLst>
          </p:cNvPr>
          <p:cNvSpPr txBox="1"/>
          <p:nvPr/>
        </p:nvSpPr>
        <p:spPr>
          <a:xfrm>
            <a:off x="6374922" y="707366"/>
            <a:ext cx="4333335" cy="5755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igure S1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aplan-Meier plots of overall survival of patients with UC in TCGA database correlated with tumoral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. Patients with higher than median tumoral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levels (red lines) have significantly shorter overall survival than patients with lower than median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RNA expression levels (black lines) in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ll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emale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ale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e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all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.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clinical stage 4, all patients, </a:t>
            </a:r>
            <a:r>
              <a:rPr lang="en-US" sz="16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.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clinical stage 4, female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male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l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male patients, and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o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white patients. Tumoral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 inverse correlation with survival in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j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male patients and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lack patients but did not reach statistical significance. A significant positive correlation between tumoral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observed in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d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all patients,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female patients, and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sian patients. No significant correlation between tumoral </a:t>
            </a:r>
            <a:r>
              <a:rPr lang="en-US" sz="16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R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found in 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h. </a:t>
            </a:r>
            <a:r>
              <a:rPr lang="en-US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female patients.</a:t>
            </a:r>
          </a:p>
        </p:txBody>
      </p:sp>
      <p:pic>
        <p:nvPicPr>
          <p:cNvPr id="5" name="Picture 4" descr="Red lines in a black background&#10;&#10;AI-generated content may be incorrect.">
            <a:extLst>
              <a:ext uri="{FF2B5EF4-FFF2-40B4-BE49-F238E27FC236}">
                <a16:creationId xmlns:a16="http://schemas.microsoft.com/office/drawing/2014/main" id="{3242DF6F-C602-B62C-6068-D8E9F688E0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36491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2127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B0ABF74-A3B7-E7F9-5D63-BAAFFC900292}"/>
              </a:ext>
            </a:extLst>
          </p:cNvPr>
          <p:cNvSpPr txBox="1"/>
          <p:nvPr/>
        </p:nvSpPr>
        <p:spPr>
          <a:xfrm>
            <a:off x="4779035" y="1259456"/>
            <a:ext cx="7412965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igure S2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aplan-Meier plots of overall survival of patients with UC in TCGA database correlated with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. Patients with higher than media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levels (red lines) have significantly shorter overall survival than patients with lower than median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RNA expression levels (black lines)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j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male patients.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 inverse correlation with survival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emale patients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d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all patients, but did not reach statistical significance. A significant positive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observe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e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all patients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.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clinical stage 3, male patients.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s a positive correlation but did not reach statistical significance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h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female patients,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l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male patients.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o significant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H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foun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female patients, </a:t>
            </a:r>
            <a:r>
              <a:rPr lang="en-US" sz="18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clinical stage 4, fe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sian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lack patients, or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o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white patients.</a:t>
            </a:r>
          </a:p>
        </p:txBody>
      </p:sp>
      <p:pic>
        <p:nvPicPr>
          <p:cNvPr id="5" name="Picture 4" descr="Red lines in the sky&#10;&#10;AI-generated content may be incorrect.">
            <a:extLst>
              <a:ext uri="{FF2B5EF4-FFF2-40B4-BE49-F238E27FC236}">
                <a16:creationId xmlns:a16="http://schemas.microsoft.com/office/drawing/2014/main" id="{2130927C-A73E-70E5-4DD1-FA1FE659B0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34152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0890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02CF0A1-1942-9F1F-48D5-E487552CB71F}"/>
              </a:ext>
            </a:extLst>
          </p:cNvPr>
          <p:cNvSpPr txBox="1"/>
          <p:nvPr/>
        </p:nvSpPr>
        <p:spPr>
          <a:xfrm>
            <a:off x="5305247" y="1078302"/>
            <a:ext cx="6282904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igure S3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aplan-Meier plots of overall survival of patients with UC in TCGA database correlated with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. Patients with higher than media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levels (red lines) have significantly shorter overall survival than patients with lower than median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RNA expression levels (black lines)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e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h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female patients,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lack patients.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 inverse correlation with survival but did not reach statistical significance in </a:t>
            </a:r>
            <a:r>
              <a:rPr lang="en-US" sz="18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female patients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j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male patients. A trend towards positive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observe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g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female patients, but statistical significance was not reached. No significant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foun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e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d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l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sian patients,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o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white patients.</a:t>
            </a:r>
          </a:p>
        </p:txBody>
      </p:sp>
      <p:pic>
        <p:nvPicPr>
          <p:cNvPr id="5" name="Picture 4" descr="A black background with red lines&#10;&#10;AI-generated content may be incorrect.">
            <a:extLst>
              <a:ext uri="{FF2B5EF4-FFF2-40B4-BE49-F238E27FC236}">
                <a16:creationId xmlns:a16="http://schemas.microsoft.com/office/drawing/2014/main" id="{5A49D14A-F762-A0D7-ED49-93F49E06CA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34662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51812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840B73-2260-20AC-5E21-F3993538E1FB}"/>
              </a:ext>
            </a:extLst>
          </p:cNvPr>
          <p:cNvSpPr txBox="1"/>
          <p:nvPr/>
        </p:nvSpPr>
        <p:spPr>
          <a:xfrm>
            <a:off x="4641013" y="1181819"/>
            <a:ext cx="7487727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igure S4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aplan-Meier plots of overall survival of patients with UC in TCGA database correlated with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. Patients with higher than media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R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levels (red lines) have significantly shorter overall survival than patients with lower than median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RNA expression levels (black lines)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l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male patients,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o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white patients.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 inverse correlation with survival in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j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male patients, but did not reach statistical significance. A significant positive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observe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lack patients.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mRNA expression trended towards a positive correlation in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g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female patients, but statistical significance was not reached.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No significant correlation between tumoral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GF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 expression and survival was found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b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fe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d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2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e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all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h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female patients, </a:t>
            </a:r>
            <a:r>
              <a:rPr lang="en-US" sz="18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i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4, female patients,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k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clinical stage 3, male patients, and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m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 (Body CS)"/>
              </a:rPr>
              <a:t>Asian patients.</a:t>
            </a:r>
          </a:p>
        </p:txBody>
      </p:sp>
      <p:pic>
        <p:nvPicPr>
          <p:cNvPr id="5" name="Picture 4" descr="A black background with red lines&#10;&#10;AI-generated content may be incorrect.">
            <a:extLst>
              <a:ext uri="{FF2B5EF4-FFF2-40B4-BE49-F238E27FC236}">
                <a16:creationId xmlns:a16="http://schemas.microsoft.com/office/drawing/2014/main" id="{C4073294-A25F-EC92-EC37-6AA725F9F4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33052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87126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bladder cancer&#10;&#10;AI-generated content may be incorrect.">
            <a:extLst>
              <a:ext uri="{FF2B5EF4-FFF2-40B4-BE49-F238E27FC236}">
                <a16:creationId xmlns:a16="http://schemas.microsoft.com/office/drawing/2014/main" id="{163F1FF4-AFAB-9704-7F4E-64B06ABF8C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2930" y="379574"/>
            <a:ext cx="10858500" cy="357905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121690E-C892-7E36-C83F-ED3DC2989E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153968"/>
            <a:ext cx="12192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</a:t>
            </a:r>
            <a:r>
              <a:rPr lang="en-US" altLang="en-US" sz="1200" i="1" dirty="0">
                <a:latin typeface="Arial" panose="020B0604020202020204" pitchFamily="34" charset="0"/>
                <a:ea typeface="Times New Roman" panose="02020603050405020304" pitchFamily="18" charset="0"/>
              </a:rPr>
              <a:t>S5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GHR protein expression data of 26 human bladder cancer cell lines sorted from left to right by expression level, showing UM-UC-3 as the bladder cancer cell line with the highest level of GHR expression. Image credit: Human Protein Atlas https://</a:t>
            </a:r>
            <a:r>
              <a:rPr lang="en-US" alt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www.proteinatlas.org</a:t>
            </a:r>
            <a:r>
              <a:rPr lang="en-US" alt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/ENSG00000112964-GHR/</a:t>
            </a:r>
            <a:r>
              <a:rPr lang="en-US" alt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cell+line#bladder_cancer</a:t>
            </a:r>
            <a:r>
              <a:rPr lang="en-US" alt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6523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D292CCAF-7E6D-EE53-FDDA-834C351265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2" descr="EC50 values of cisplatin and gemcitabine chemotherapies in a.-b. UM-UC-3 human UC and c.-d. MB49 murine UC cell lines">
            <a:extLst>
              <a:ext uri="{FF2B5EF4-FFF2-40B4-BE49-F238E27FC236}">
                <a16:creationId xmlns:a16="http://schemas.microsoft.com/office/drawing/2014/main" id="{FAAE1DE0-4B0F-2623-143A-D157260A37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3250" y="274320"/>
            <a:ext cx="5486400" cy="4470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2AC99A35-10DB-AB3B-52D1-1E919156ED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061635"/>
            <a:ext cx="121920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</a:t>
            </a:r>
            <a:r>
              <a:rPr lang="en-US" altLang="en-US" sz="1200" i="1" dirty="0">
                <a:latin typeface="Arial" panose="020B0604020202020204" pitchFamily="34" charset="0"/>
                <a:ea typeface="Times New Roman" panose="02020603050405020304" pitchFamily="18" charset="0"/>
              </a:rPr>
              <a:t>S6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C</a:t>
            </a:r>
            <a:r>
              <a:rPr kumimoji="0" lang="en-US" altLang="en-US" sz="12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values of cisplatin and gemcitabine chemotherapies in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.-b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UM-UC-3 human UC and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.-d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B49 murine UC cell lines. Resazurin-resorufin cell viability assay (72 hours) was used for 10-dose determination of EC</a:t>
            </a:r>
            <a:r>
              <a:rPr kumimoji="0" lang="en-US" altLang="en-US" sz="12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96-well plate format with 50,000 cells/well. Percent inhibition was calculated and nonlinear regression (variable slope – four parameters) was used to calculate EC</a:t>
            </a:r>
            <a:r>
              <a:rPr kumimoji="0" lang="en-US" altLang="en-US" sz="12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value using Prism 10 software (GraphPad).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1688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48</TotalTime>
  <Words>1027</Words>
  <Application>Microsoft Macintosh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s, Emily</dc:creator>
  <cp:lastModifiedBy>Davis, Emily</cp:lastModifiedBy>
  <cp:revision>2</cp:revision>
  <dcterms:created xsi:type="dcterms:W3CDTF">2025-05-27T14:20:31Z</dcterms:created>
  <dcterms:modified xsi:type="dcterms:W3CDTF">2025-07-18T15:55:17Z</dcterms:modified>
</cp:coreProperties>
</file>